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7D5245-24BB-4DE0-8213-AF2ECAEEFA5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B1A903-CFF6-4803-8471-5E610380523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52318F-B690-44B5-AD44-7BDEB689E3A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80D0AF-E7E9-4ADD-BEEE-829DC53F61C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48DE7F-928B-4023-9B20-14E025C0FBC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ED403A-CC90-4236-A1AA-C12ADDA0E73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63AA44-C77E-410A-9A46-9FB1540D23A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C4632D-DC0D-4645-84D1-5770320F2A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3A99A8-ECDC-4767-B246-EC1C0903F29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949342-CF71-431A-9C60-BBB105F68A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104EF5-8A80-460A-BD3A-A1BBB0B5B0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9EED50-3714-4A17-B234-7E7D6C5E10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AB7D9C2-E427-4850-9062-DFB1C35B6F9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903320" y="1104840"/>
            <a:ext cx="228600" cy="171360"/>
          </a:xfrm>
          <a:prstGeom prst="rightArrow">
            <a:avLst>
              <a:gd name="adj1" fmla="val 50000"/>
              <a:gd name="adj2" fmla="val 33351"/>
            </a:avLst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8880" bIns="388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362240" y="1190520"/>
            <a:ext cx="4195440" cy="972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080" bIns="-370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151000" y="1143000"/>
            <a:ext cx="1055880" cy="1062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324240" y="1141560"/>
            <a:ext cx="849240" cy="10764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5538240" y="1065240"/>
            <a:ext cx="8298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pMiR-Report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rot="2234400">
            <a:off x="2544480" y="1026720"/>
            <a:ext cx="98280" cy="324000"/>
          </a:xfrm>
          <a:custGeom>
            <a:avLst/>
            <a:gdLst/>
            <a:ahLst/>
            <a:rect l="l" t="t" r="r" b="b"/>
            <a:pathLst>
              <a:path w="144" h="240">
                <a:moveTo>
                  <a:pt x="96" y="0"/>
                </a:moveTo>
                <a:lnTo>
                  <a:pt x="0" y="144"/>
                </a:lnTo>
                <a:lnTo>
                  <a:pt x="144" y="96"/>
                </a:lnTo>
                <a:lnTo>
                  <a:pt x="48" y="240"/>
                </a:lnTo>
              </a:path>
            </a:pathLst>
          </a:custGeom>
          <a:blipFill rotWithShape="0">
            <a:blip r:embed="rId1"/>
            <a:srcRect/>
            <a:tile tx="0" ty="0" sx="100000" sy="100000" algn="ctr"/>
          </a:blipFill>
          <a:ln w="2844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 rot="17708400">
            <a:off x="2381040" y="574200"/>
            <a:ext cx="872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luciferase gen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 rot="17704800">
            <a:off x="1481040" y="594360"/>
            <a:ext cx="843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CMV promote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2155680" y="1077840"/>
            <a:ext cx="0" cy="108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 rot="16200000">
            <a:off x="1892160" y="833760"/>
            <a:ext cx="438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 Narrow"/>
                <a:ea typeface="宋体"/>
              </a:rPr>
              <a:t>BamH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 rot="16138800">
            <a:off x="3141720" y="830880"/>
            <a:ext cx="348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 Narrow"/>
                <a:ea typeface="宋体"/>
              </a:rPr>
              <a:t>Sac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rot="16128600">
            <a:off x="4693320" y="856440"/>
            <a:ext cx="334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 Narrow"/>
                <a:ea typeface="宋体"/>
              </a:rPr>
              <a:t>Not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3324240" y="1069920"/>
            <a:ext cx="0" cy="108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rot="17707800">
            <a:off x="4307760" y="561240"/>
            <a:ext cx="976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SV40 late poly(A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4471920" y="1143000"/>
            <a:ext cx="319320" cy="108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 rot="17703600">
            <a:off x="3280320" y="575640"/>
            <a:ext cx="912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宋体"/>
              </a:rPr>
              <a:t>target sequenc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flipH="1">
            <a:off x="1414440" y="1246320"/>
            <a:ext cx="1920960" cy="35244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4164120" y="1235160"/>
            <a:ext cx="1773000" cy="350640"/>
          </a:xfrm>
          <a:prstGeom prst="line">
            <a:avLst/>
          </a:prstGeom>
          <a:ln cap="rnd" w="9360">
            <a:solidFill>
              <a:srgbClr val="000000"/>
            </a:solidFill>
            <a:custDash>
              <a:ds d="100000" sp="1000"/>
            </a:custDash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479600" y="1141560"/>
            <a:ext cx="596880" cy="1047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1254240" y="1546200"/>
            <a:ext cx="489564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400" spc="-1" strike="noStrike" u="sng">
                <a:solidFill>
                  <a:srgbClr val="000000"/>
                </a:solidFill>
                <a:uFillTx/>
                <a:latin typeface="Courier New"/>
                <a:ea typeface="宋体"/>
              </a:rPr>
              <a:t>gagctc</a:t>
            </a:r>
            <a:r>
              <a:rPr b="0" lang="en-CA" sz="1400" spc="-1" strike="noStrike">
                <a:solidFill>
                  <a:srgbClr val="000000"/>
                </a:solidFill>
                <a:latin typeface="Courier New"/>
                <a:ea typeface="宋体"/>
              </a:rPr>
              <a:t>gaattc</a:t>
            </a:r>
            <a:r>
              <a:rPr b="0" lang="en-CA" sz="1400" spc="-1" strike="noStrike" u="sng">
                <a:solidFill>
                  <a:srgbClr val="000000"/>
                </a:solidFill>
                <a:uFillTx/>
                <a:latin typeface="Courier New"/>
                <a:ea typeface="宋体"/>
              </a:rPr>
              <a:t>cacctacaccattatcttggaaagaaacaaccgttggaaacata</a:t>
            </a:r>
            <a:r>
              <a:rPr b="0" lang="en-CA" sz="1400" spc="-1" strike="noStrike">
                <a:solidFill>
                  <a:srgbClr val="000000"/>
                </a:solidFill>
                <a:latin typeface="Courier New"/>
                <a:ea typeface="宋体"/>
              </a:rPr>
              <a:t>accattacag </a:t>
            </a:r>
            <a:r>
              <a:rPr b="0" lang="en-CA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••••••••••••••• </a:t>
            </a:r>
            <a:r>
              <a:rPr b="0" lang="en-CA" sz="1400" spc="-1" strike="noStrike">
                <a:solidFill>
                  <a:srgbClr val="000000"/>
                </a:solidFill>
                <a:latin typeface="Courier New"/>
                <a:ea typeface="宋体"/>
              </a:rPr>
              <a:t>cctacaatgta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400" spc="-1" strike="noStrike">
                <a:solidFill>
                  <a:srgbClr val="000000"/>
                </a:solidFill>
                <a:latin typeface="Courier New"/>
                <a:ea typeface="宋体"/>
              </a:rPr>
              <a:t>c</a:t>
            </a:r>
            <a:r>
              <a:rPr b="1" lang="en-CA" sz="1400" spc="-1" strike="noStrike">
                <a:solidFill>
                  <a:srgbClr val="333399"/>
                </a:solidFill>
                <a:latin typeface="Courier New"/>
                <a:ea typeface="宋体"/>
              </a:rPr>
              <a:t>aggaagagc</a:t>
            </a:r>
            <a:r>
              <a:rPr b="1" lang="en-CA" sz="1400" spc="-1" strike="noStrike" u="sng">
                <a:solidFill>
                  <a:srgbClr val="000000"/>
                </a:solidFill>
                <a:uFillTx/>
                <a:latin typeface="Courier New"/>
                <a:ea typeface="宋体"/>
              </a:rPr>
              <a:t>acgcg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 rot="16138800">
            <a:off x="4177800" y="799200"/>
            <a:ext cx="423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 Narrow"/>
                <a:ea typeface="宋体"/>
              </a:rPr>
              <a:t>HindII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4859280" y="1076400"/>
            <a:ext cx="0" cy="108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 rot="16128600">
            <a:off x="4000320" y="842760"/>
            <a:ext cx="339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 Narrow"/>
                <a:ea typeface="宋体"/>
              </a:rPr>
              <a:t>Mlu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4175280" y="1068480"/>
            <a:ext cx="0" cy="108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4400640" y="1071720"/>
            <a:ext cx="0" cy="1076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342000" y="1746360"/>
            <a:ext cx="8175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Luc-</a:t>
            </a:r>
            <a:r>
              <a:rPr b="1" lang="en-CA" sz="900" spc="-1" strike="noStrike">
                <a:solidFill>
                  <a:srgbClr val="000000"/>
                </a:solidFill>
                <a:latin typeface="Arial"/>
                <a:ea typeface="宋体"/>
              </a:rPr>
              <a:t>CD44-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342000" y="2732040"/>
            <a:ext cx="823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Luc-</a:t>
            </a:r>
            <a:r>
              <a:rPr b="1" lang="en-CA" sz="900" spc="-1" strike="noStrike">
                <a:solidFill>
                  <a:srgbClr val="000000"/>
                </a:solidFill>
                <a:latin typeface="Arial"/>
                <a:ea typeface="宋体"/>
              </a:rPr>
              <a:t>CD44-b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469440" y="6826320"/>
            <a:ext cx="6195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Luc-Ctrl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1219320" y="6468840"/>
            <a:ext cx="4967280" cy="94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 u="sng">
                <a:solidFill>
                  <a:srgbClr val="000000"/>
                </a:solidFill>
                <a:uFillTx/>
                <a:latin typeface="Courier New"/>
                <a:ea typeface="宋体"/>
              </a:rPr>
              <a:t>actagt</a:t>
            </a:r>
            <a:r>
              <a:rPr b="0" lang="en-US" sz="1400" spc="-1" strike="noStrike">
                <a:solidFill>
                  <a:srgbClr val="000000"/>
                </a:solidFill>
                <a:latin typeface="Courier New"/>
                <a:ea typeface="宋体"/>
              </a:rPr>
              <a:t>aatggagccacatgtatagatggcctcaatacatttacttgcctgtgtctaccaagctat</a:t>
            </a:r>
            <a:r>
              <a:rPr b="0" lang="en-CA" sz="1400" spc="-1" strike="noStrike">
                <a:solidFill>
                  <a:srgbClr val="000000"/>
                </a:solidFill>
                <a:latin typeface="Courier New"/>
                <a:ea typeface="宋体"/>
              </a:rPr>
              <a:t> </a:t>
            </a:r>
            <a:r>
              <a:rPr b="0" lang="en-CA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••••••••••••••• </a:t>
            </a:r>
            <a:r>
              <a:rPr b="0" lang="en-US" sz="1400" spc="-1" strike="noStrike">
                <a:solidFill>
                  <a:srgbClr val="000000"/>
                </a:solidFill>
                <a:latin typeface="Courier New"/>
                <a:ea typeface="宋体"/>
              </a:rPr>
              <a:t>cattttatccc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ourier New"/>
                <a:ea typeface="宋体"/>
              </a:rPr>
              <a:t>tgaggaacaagtcttcgtgaaccgtattgggcacgactaccagtggattggcctcaatgacaagatgtttgagcgtgatttc</a:t>
            </a:r>
            <a:r>
              <a:rPr b="1" lang="en-US" sz="1400" spc="-1" strike="noStrike" u="sng">
                <a:solidFill>
                  <a:srgbClr val="000000"/>
                </a:solidFill>
                <a:uFillTx/>
                <a:latin typeface="Courier New"/>
                <a:ea typeface="宋体"/>
              </a:rPr>
              <a:t>gagctc</a:t>
            </a:r>
            <a:r>
              <a:rPr b="0" lang="en-US" sz="1400" spc="-1" strike="noStrike">
                <a:solidFill>
                  <a:srgbClr val="000000"/>
                </a:solidFill>
                <a:latin typeface="Courier New"/>
                <a:ea typeface="宋体"/>
              </a:rPr>
              <a:t>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3251160" y="1084320"/>
            <a:ext cx="0" cy="1080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rot="16138800">
            <a:off x="3027600" y="831240"/>
            <a:ext cx="354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 Narrow"/>
                <a:ea typeface="宋体"/>
              </a:rPr>
              <a:t>Spe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348480" y="3927600"/>
            <a:ext cx="8175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Luc-</a:t>
            </a:r>
            <a:r>
              <a:rPr b="1" lang="en-CA" sz="900" spc="-1" strike="noStrike">
                <a:solidFill>
                  <a:srgbClr val="000000"/>
                </a:solidFill>
                <a:latin typeface="Arial"/>
                <a:ea typeface="宋体"/>
              </a:rPr>
              <a:t>CD44-c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342000" y="5241960"/>
            <a:ext cx="8236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  <a:ea typeface="宋体"/>
              </a:rPr>
              <a:t>Luc-</a:t>
            </a:r>
            <a:r>
              <a:rPr b="1" lang="en-CA" sz="900" spc="-1" strike="noStrike">
                <a:solidFill>
                  <a:srgbClr val="000000"/>
                </a:solidFill>
                <a:latin typeface="Arial"/>
                <a:ea typeface="宋体"/>
              </a:rPr>
              <a:t>CD44-d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1258920" y="2441880"/>
            <a:ext cx="489564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400" spc="-1" strike="noStrike" u="sng">
                <a:solidFill>
                  <a:srgbClr val="000000"/>
                </a:solidFill>
                <a:uFillTx/>
                <a:latin typeface="Courier New"/>
                <a:ea typeface="宋体"/>
              </a:rPr>
              <a:t>gagctc</a:t>
            </a:r>
            <a:r>
              <a:rPr b="0" lang="en-CA" sz="1400" spc="-1" strike="noStrike">
                <a:solidFill>
                  <a:srgbClr val="000000"/>
                </a:solidFill>
                <a:latin typeface="Courier New"/>
                <a:ea typeface="宋体"/>
              </a:rPr>
              <a:t>gaattc</a:t>
            </a:r>
            <a:r>
              <a:rPr b="0" lang="en-CA" sz="1400" spc="-1" strike="noStrike" u="sng">
                <a:solidFill>
                  <a:srgbClr val="000000"/>
                </a:solidFill>
                <a:uFillTx/>
                <a:latin typeface="Courier New"/>
                <a:ea typeface="宋体"/>
              </a:rPr>
              <a:t>cacctacaccattatcttggaaagaaacaaccgttggaaacata</a:t>
            </a:r>
            <a:r>
              <a:rPr b="0" lang="en-CA" sz="1400" spc="-1" strike="noStrike">
                <a:solidFill>
                  <a:srgbClr val="000000"/>
                </a:solidFill>
                <a:latin typeface="Courier New"/>
                <a:ea typeface="宋体"/>
              </a:rPr>
              <a:t>accattacag </a:t>
            </a:r>
            <a:r>
              <a:rPr b="0" lang="en-CA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••••••••••••••• </a:t>
            </a:r>
            <a:r>
              <a:rPr b="0" lang="en-CA" sz="1400" spc="-1" strike="noStrike">
                <a:solidFill>
                  <a:srgbClr val="000000"/>
                </a:solidFill>
                <a:latin typeface="Courier New"/>
                <a:ea typeface="宋体"/>
              </a:rPr>
              <a:t>cctacaatgta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400" spc="-1" strike="noStrike">
                <a:solidFill>
                  <a:srgbClr val="000000"/>
                </a:solidFill>
                <a:latin typeface="Courier New"/>
                <a:ea typeface="宋体"/>
              </a:rPr>
              <a:t>c</a:t>
            </a:r>
            <a:r>
              <a:rPr b="1" lang="en-CA" sz="1400" spc="-1" strike="noStrike">
                <a:solidFill>
                  <a:srgbClr val="333399"/>
                </a:solidFill>
                <a:latin typeface="Courier New"/>
                <a:ea typeface="宋体"/>
              </a:rPr>
              <a:t>aggaagagctgagaatggtaag</a:t>
            </a:r>
            <a:r>
              <a:rPr b="0" lang="en-CA" sz="1400" spc="-1" strike="noStrike">
                <a:solidFill>
                  <a:srgbClr val="000000"/>
                </a:solidFill>
                <a:latin typeface="Courier New"/>
                <a:ea typeface="宋体"/>
              </a:rPr>
              <a:t>gaga</a:t>
            </a:r>
            <a:r>
              <a:rPr b="1" lang="en-CA" sz="1400" spc="-1" strike="noStrike" u="sng">
                <a:solidFill>
                  <a:srgbClr val="000000"/>
                </a:solidFill>
                <a:uFillTx/>
                <a:latin typeface="Courier New"/>
                <a:ea typeface="宋体"/>
              </a:rPr>
              <a:t>acgcg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1268280" y="3412800"/>
            <a:ext cx="489600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400" spc="-1" strike="noStrike" u="sng">
                <a:solidFill>
                  <a:srgbClr val="000000"/>
                </a:solidFill>
                <a:uFillTx/>
                <a:latin typeface="Courier New"/>
                <a:ea typeface="宋体"/>
              </a:rPr>
              <a:t>gagctc</a:t>
            </a:r>
            <a:r>
              <a:rPr b="0" lang="en-CA" sz="1400" spc="-1" strike="noStrike">
                <a:solidFill>
                  <a:srgbClr val="000000"/>
                </a:solidFill>
                <a:latin typeface="Courier New"/>
                <a:ea typeface="宋体"/>
              </a:rPr>
              <a:t>gaattc</a:t>
            </a:r>
            <a:r>
              <a:rPr b="0" lang="en-CA" sz="1400" spc="-1" strike="noStrike" u="sng">
                <a:solidFill>
                  <a:srgbClr val="000000"/>
                </a:solidFill>
                <a:uFillTx/>
                <a:latin typeface="Courier New"/>
                <a:ea typeface="宋体"/>
              </a:rPr>
              <a:t>cacctacaccattatcttggaaagaaacaaccgttggaaacata</a:t>
            </a:r>
            <a:r>
              <a:rPr b="0" lang="en-CA" sz="1400" spc="-1" strike="noStrike">
                <a:solidFill>
                  <a:srgbClr val="000000"/>
                </a:solidFill>
                <a:latin typeface="Courier New"/>
                <a:ea typeface="宋体"/>
              </a:rPr>
              <a:t>accattacag </a:t>
            </a:r>
            <a:r>
              <a:rPr b="0" lang="en-CA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••••••••••••••• </a:t>
            </a:r>
            <a:r>
              <a:rPr b="0" lang="en-CA" sz="1400" spc="-1" strike="noStrike">
                <a:solidFill>
                  <a:srgbClr val="000000"/>
                </a:solidFill>
                <a:latin typeface="Courier New"/>
                <a:ea typeface="宋体"/>
              </a:rPr>
              <a:t>cctacaatgta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400" spc="-1" strike="noStrike">
                <a:solidFill>
                  <a:srgbClr val="000000"/>
                </a:solidFill>
                <a:latin typeface="Courier New"/>
                <a:ea typeface="宋体"/>
              </a:rPr>
              <a:t>c</a:t>
            </a:r>
            <a:r>
              <a:rPr b="1" lang="en-CA" sz="1400" spc="-1" strike="noStrike">
                <a:solidFill>
                  <a:srgbClr val="333399"/>
                </a:solidFill>
                <a:latin typeface="Courier New"/>
                <a:ea typeface="宋体"/>
              </a:rPr>
              <a:t>aggaagagctgagaatggtaag</a:t>
            </a:r>
            <a:r>
              <a:rPr b="0" lang="en-CA" sz="1400" spc="-1" strike="noStrike">
                <a:solidFill>
                  <a:srgbClr val="000000"/>
                </a:solidFill>
                <a:latin typeface="Courier New"/>
                <a:ea typeface="宋体"/>
              </a:rPr>
              <a:t>gagactcttctaagtcttcatctcagagaccctgagttcccactcagacccactcagccaaatct</a:t>
            </a:r>
            <a:r>
              <a:rPr b="1" lang="en-CA" sz="1400" spc="-1" strike="noStrike">
                <a:solidFill>
                  <a:srgbClr val="cc00cc"/>
                </a:solidFill>
                <a:latin typeface="Courier New"/>
                <a:ea typeface="宋体"/>
              </a:rPr>
              <a:t>catggaagaccaaggagggcag</a:t>
            </a:r>
            <a:r>
              <a:rPr b="0" lang="en-CA" sz="1400" spc="-1" strike="noStrike">
                <a:solidFill>
                  <a:srgbClr val="000000"/>
                </a:solidFill>
                <a:latin typeface="Courier New"/>
                <a:ea typeface="宋体"/>
              </a:rPr>
              <a:t>cact</a:t>
            </a:r>
            <a:r>
              <a:rPr b="1" lang="en-CA" sz="1400" spc="-1" strike="noStrike" u="sng">
                <a:solidFill>
                  <a:srgbClr val="000000"/>
                </a:solidFill>
                <a:uFillTx/>
                <a:latin typeface="Courier New"/>
                <a:ea typeface="宋体"/>
              </a:rPr>
              <a:t>acgcg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1268280" y="4698360"/>
            <a:ext cx="4896000" cy="158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CA" sz="1400" spc="-1" strike="noStrike" u="sng">
                <a:solidFill>
                  <a:srgbClr val="000000"/>
                </a:solidFill>
                <a:uFillTx/>
                <a:latin typeface="Courier New"/>
                <a:ea typeface="宋体"/>
              </a:rPr>
              <a:t>gagctc</a:t>
            </a:r>
            <a:r>
              <a:rPr b="0" lang="en-CA" sz="1400" spc="-1" strike="noStrike">
                <a:solidFill>
                  <a:srgbClr val="000000"/>
                </a:solidFill>
                <a:latin typeface="Courier New"/>
                <a:ea typeface="宋体"/>
              </a:rPr>
              <a:t>gaattc</a:t>
            </a:r>
            <a:r>
              <a:rPr b="0" lang="en-CA" sz="1400" spc="-1" strike="noStrike" u="sng">
                <a:solidFill>
                  <a:srgbClr val="000000"/>
                </a:solidFill>
                <a:uFillTx/>
                <a:latin typeface="Courier New"/>
                <a:ea typeface="宋体"/>
              </a:rPr>
              <a:t>cacctacaccattatcttggaaagaaacaaccgttggaaacata</a:t>
            </a:r>
            <a:r>
              <a:rPr b="0" lang="en-CA" sz="1400" spc="-1" strike="noStrike">
                <a:solidFill>
                  <a:srgbClr val="000000"/>
                </a:solidFill>
                <a:latin typeface="Courier New"/>
                <a:ea typeface="宋体"/>
              </a:rPr>
              <a:t>accattacag </a:t>
            </a:r>
            <a:r>
              <a:rPr b="0" lang="en-CA" sz="1400" spc="-1" strike="noStrike">
                <a:solidFill>
                  <a:srgbClr val="000000"/>
                </a:solidFill>
                <a:latin typeface="Times New Roman"/>
                <a:ea typeface="宋体"/>
              </a:rPr>
              <a:t>••••••••••••••• </a:t>
            </a:r>
            <a:r>
              <a:rPr b="0" lang="en-CA" sz="1400" spc="-1" strike="noStrike">
                <a:solidFill>
                  <a:srgbClr val="000000"/>
                </a:solidFill>
                <a:latin typeface="Courier New"/>
                <a:ea typeface="宋体"/>
              </a:rPr>
              <a:t>cctacaatgta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400" spc="-1" strike="noStrike">
                <a:solidFill>
                  <a:srgbClr val="000000"/>
                </a:solidFill>
                <a:latin typeface="Courier New"/>
                <a:ea typeface="宋体"/>
              </a:rPr>
              <a:t>c</a:t>
            </a:r>
            <a:r>
              <a:rPr b="1" lang="en-CA" sz="1400" spc="-1" strike="noStrike">
                <a:solidFill>
                  <a:srgbClr val="333399"/>
                </a:solidFill>
                <a:latin typeface="Courier New"/>
                <a:ea typeface="宋体"/>
              </a:rPr>
              <a:t>aggaagagctgagaatggtaag</a:t>
            </a:r>
            <a:r>
              <a:rPr b="0" lang="en-CA" sz="1400" spc="-1" strike="noStrike">
                <a:solidFill>
                  <a:srgbClr val="000000"/>
                </a:solidFill>
                <a:latin typeface="Courier New"/>
                <a:ea typeface="宋体"/>
              </a:rPr>
              <a:t>gagactcttctaagtcttcatctcagagaccctgagttcccactcagacccactcagccaaatct</a:t>
            </a:r>
            <a:r>
              <a:rPr b="1" lang="en-CA" sz="1400" spc="-1" strike="noStrike">
                <a:solidFill>
                  <a:srgbClr val="cc00cc"/>
                </a:solidFill>
                <a:latin typeface="Courier New"/>
                <a:ea typeface="宋体"/>
              </a:rPr>
              <a:t>catggaagaccaaggagggcag</a:t>
            </a:r>
            <a:r>
              <a:rPr b="0" lang="en-CA" sz="1400" spc="-1" strike="noStrike">
                <a:solidFill>
                  <a:srgbClr val="000000"/>
                </a:solidFill>
                <a:latin typeface="Courier New"/>
                <a:ea typeface="宋体"/>
              </a:rPr>
              <a:t>cactgtttttgttttttgttttttgttttttttttttgacactgtccaaaggttttccatcctgtcctggaatcagag</a:t>
            </a:r>
            <a:r>
              <a:rPr b="1" lang="en-CA" sz="1400" spc="-1" strike="noStrike">
                <a:solidFill>
                  <a:srgbClr val="ff0000"/>
                </a:solidFill>
                <a:latin typeface="Courier New"/>
                <a:ea typeface="宋体"/>
              </a:rPr>
              <a:t>ttggaagctgaggagcttcag</a:t>
            </a:r>
            <a:r>
              <a:rPr b="0" lang="en-CA" sz="1400" spc="-1" strike="noStrike">
                <a:solidFill>
                  <a:srgbClr val="000000"/>
                </a:solidFill>
                <a:latin typeface="Courier New"/>
                <a:ea typeface="宋体"/>
              </a:rPr>
              <a:t>cctct</a:t>
            </a:r>
            <a:r>
              <a:rPr b="1" lang="en-CA" sz="1400" spc="-1" strike="noStrike" u="sng">
                <a:solidFill>
                  <a:srgbClr val="000000"/>
                </a:solidFill>
                <a:uFillTx/>
                <a:latin typeface="Courier New"/>
                <a:ea typeface="宋体"/>
              </a:rPr>
              <a:t>acgcg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5-08T15:44:31Z</dcterms:created>
  <dc:creator>B. Yang</dc:creator>
  <dc:description/>
  <dc:language>en-US</dc:language>
  <cp:lastModifiedBy>B. Yang</cp:lastModifiedBy>
  <dcterms:modified xsi:type="dcterms:W3CDTF">2008-05-08T15:48:47Z</dcterms:modified>
  <cp:revision>1</cp:revision>
  <dc:subject/>
  <dc:title>Slide 1</dc:title>
</cp:coreProperties>
</file>